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2" r:id="rId3"/>
    <p:sldId id="258" r:id="rId4"/>
    <p:sldId id="264" r:id="rId5"/>
    <p:sldId id="261" r:id="rId6"/>
    <p:sldId id="259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32" autoAdjust="0"/>
    <p:restoredTop sz="94660"/>
  </p:normalViewPr>
  <p:slideViewPr>
    <p:cSldViewPr snapToGrid="0">
      <p:cViewPr varScale="1">
        <p:scale>
          <a:sx n="136" d="100"/>
          <a:sy n="136" d="100"/>
        </p:scale>
        <p:origin x="1005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90810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91224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8958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0359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64370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74591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33191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569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11637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01813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3796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0BD78-DC58-4BA7-8807-F973CCC226E8}" type="datetimeFigureOut">
              <a:rPr lang="zh-CN" altLang="en-US" smtClean="0"/>
              <a:t>2021/12/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97FEA0-1761-48E2-B7F6-A3F73885CF8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980260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文本框 16">
            <a:extLst>
              <a:ext uri="{FF2B5EF4-FFF2-40B4-BE49-F238E27FC236}">
                <a16:creationId xmlns:a16="http://schemas.microsoft.com/office/drawing/2014/main" id="{919826A3-DABE-4128-8816-D933DAD4B176}"/>
              </a:ext>
            </a:extLst>
          </p:cNvPr>
          <p:cNvSpPr txBox="1"/>
          <p:nvPr/>
        </p:nvSpPr>
        <p:spPr>
          <a:xfrm>
            <a:off x="1561262" y="264375"/>
            <a:ext cx="639919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ntrol</a:t>
            </a:r>
            <a:endParaRPr lang="zh-CN" altLang="en-US" sz="1051" b="1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35875C2-AE8A-4457-AFB8-C6E15EA72797}"/>
              </a:ext>
            </a:extLst>
          </p:cNvPr>
          <p:cNvSpPr txBox="1"/>
          <p:nvPr/>
        </p:nvSpPr>
        <p:spPr>
          <a:xfrm>
            <a:off x="3108873" y="264373"/>
            <a:ext cx="1023037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Cl</a:t>
            </a:r>
            <a:r>
              <a:rPr lang="en-US" altLang="zh-CN" sz="751" b="1" dirty="0"/>
              <a:t>2</a:t>
            </a:r>
            <a:r>
              <a:rPr lang="en-US" altLang="zh-CN" sz="1051" b="1" dirty="0"/>
              <a:t> 10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087EC99B-9690-4599-B98D-7D78B6CC99BC}"/>
              </a:ext>
            </a:extLst>
          </p:cNvPr>
          <p:cNvSpPr txBox="1"/>
          <p:nvPr/>
        </p:nvSpPr>
        <p:spPr>
          <a:xfrm>
            <a:off x="5059097" y="264373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1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83B3EBBB-CC6A-4BB6-A6D3-4B918856EE76}"/>
              </a:ext>
            </a:extLst>
          </p:cNvPr>
          <p:cNvSpPr txBox="1"/>
          <p:nvPr/>
        </p:nvSpPr>
        <p:spPr>
          <a:xfrm>
            <a:off x="6884139" y="264372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2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BEC4788-AB4D-467F-A771-1BBDE45F5B48}"/>
              </a:ext>
            </a:extLst>
          </p:cNvPr>
          <p:cNvSpPr txBox="1"/>
          <p:nvPr/>
        </p:nvSpPr>
        <p:spPr>
          <a:xfrm>
            <a:off x="1036034" y="2093403"/>
            <a:ext cx="639919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ntrol</a:t>
            </a:r>
            <a:endParaRPr lang="zh-CN" altLang="en-US" sz="1051" b="1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37AA4637-1766-4A54-8821-D7C6BDD6ECA4}"/>
              </a:ext>
            </a:extLst>
          </p:cNvPr>
          <p:cNvSpPr txBox="1"/>
          <p:nvPr/>
        </p:nvSpPr>
        <p:spPr>
          <a:xfrm>
            <a:off x="3050713" y="2079346"/>
            <a:ext cx="1023037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Cl</a:t>
            </a:r>
            <a:r>
              <a:rPr lang="en-US" altLang="zh-CN" sz="751" b="1" dirty="0"/>
              <a:t>2</a:t>
            </a:r>
            <a:r>
              <a:rPr lang="en-US" altLang="zh-CN" sz="1051" b="1" dirty="0"/>
              <a:t> 10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BC4B6A6-11F8-43A8-A0DF-B0C3AC2BF046}"/>
              </a:ext>
            </a:extLst>
          </p:cNvPr>
          <p:cNvSpPr txBox="1"/>
          <p:nvPr/>
        </p:nvSpPr>
        <p:spPr>
          <a:xfrm>
            <a:off x="5278196" y="2093405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1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E08E305-6992-4C6F-9F82-7C7285F08B3D}"/>
              </a:ext>
            </a:extLst>
          </p:cNvPr>
          <p:cNvSpPr txBox="1"/>
          <p:nvPr/>
        </p:nvSpPr>
        <p:spPr>
          <a:xfrm>
            <a:off x="7484034" y="2093403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2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12CC8CA-5B7D-4814-BDDD-8586CDCCA4BC}"/>
              </a:ext>
            </a:extLst>
          </p:cNvPr>
          <p:cNvSpPr txBox="1"/>
          <p:nvPr/>
        </p:nvSpPr>
        <p:spPr>
          <a:xfrm>
            <a:off x="835674" y="5152555"/>
            <a:ext cx="7686603" cy="7159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1 CANA inhibited hypoxia-induced metastasis in Hep3B cells. (A) </a:t>
            </a:r>
            <a:r>
              <a:rPr lang="en-US" altLang="zh-CN" sz="1351" dirty="0" err="1"/>
              <a:t>Transwell</a:t>
            </a:r>
            <a:r>
              <a:rPr lang="en-US" altLang="zh-CN" sz="1351" dirty="0"/>
              <a:t>  and (B)wound healing assays  were performed to determine the migration of Hep3B cells. Control, normal untreated control; CANA, CANA-treated CoCl</a:t>
            </a:r>
            <a:r>
              <a:rPr lang="en-US" altLang="zh-CN" sz="9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  <a:endParaRPr lang="zh-CN" altLang="en-US" sz="135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64E222C-0853-4E9C-BD55-0E8625BF97C3}"/>
              </a:ext>
            </a:extLst>
          </p:cNvPr>
          <p:cNvSpPr txBox="1"/>
          <p:nvPr/>
        </p:nvSpPr>
        <p:spPr>
          <a:xfrm>
            <a:off x="10501" y="2834387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0 h</a:t>
            </a:r>
            <a:endParaRPr lang="zh-CN" altLang="en-US" sz="1200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74DD5F3B-01E0-436A-8BEB-65AEFD3F6D46}"/>
              </a:ext>
            </a:extLst>
          </p:cNvPr>
          <p:cNvSpPr txBox="1"/>
          <p:nvPr/>
        </p:nvSpPr>
        <p:spPr>
          <a:xfrm>
            <a:off x="-53333" y="4184438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CD41730-B667-4247-8319-2BC95E4D204A}"/>
              </a:ext>
            </a:extLst>
          </p:cNvPr>
          <p:cNvSpPr txBox="1"/>
          <p:nvPr/>
        </p:nvSpPr>
        <p:spPr>
          <a:xfrm>
            <a:off x="414273" y="1114534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424826F4-80DF-48C0-9209-9DE6F0E0F15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6151" y="476195"/>
            <a:ext cx="1613672" cy="135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9E7094F2-FF02-40F9-B4E2-E2830FB401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7564" y="476195"/>
            <a:ext cx="1613672" cy="1350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12775FC6-194A-4805-8F46-36A7ACF3202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24284" y="476195"/>
            <a:ext cx="1613672" cy="135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84047B53-4C42-4EB8-8662-3825D11C715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976" y="476195"/>
            <a:ext cx="1613672" cy="13500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03BA3A3-4BC6-42E3-8262-237D9372A2D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539" y="2336747"/>
            <a:ext cx="8594876" cy="2455679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8CD2BF29-1C8C-4216-AEE5-9CF867502647}"/>
              </a:ext>
            </a:extLst>
          </p:cNvPr>
          <p:cNvSpPr txBox="1"/>
          <p:nvPr/>
        </p:nvSpPr>
        <p:spPr>
          <a:xfrm>
            <a:off x="180283" y="68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C058D79-0141-42DE-A74A-C0D7CDCD949C}"/>
              </a:ext>
            </a:extLst>
          </p:cNvPr>
          <p:cNvSpPr txBox="1"/>
          <p:nvPr/>
        </p:nvSpPr>
        <p:spPr>
          <a:xfrm>
            <a:off x="180283" y="184923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083014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84EB2682-126D-46AF-8B49-4AD1257754C4}"/>
              </a:ext>
            </a:extLst>
          </p:cNvPr>
          <p:cNvSpPr txBox="1"/>
          <p:nvPr/>
        </p:nvSpPr>
        <p:spPr>
          <a:xfrm>
            <a:off x="17324" y="2658427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0 h</a:t>
            </a:r>
            <a:endParaRPr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A44C2FFC-CBA6-4A64-8F8D-5F769D26E952}"/>
              </a:ext>
            </a:extLst>
          </p:cNvPr>
          <p:cNvSpPr txBox="1"/>
          <p:nvPr/>
        </p:nvSpPr>
        <p:spPr>
          <a:xfrm>
            <a:off x="2" y="4069189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8351965-7844-4E52-8C6A-216C1CBB47A0}"/>
              </a:ext>
            </a:extLst>
          </p:cNvPr>
          <p:cNvSpPr txBox="1"/>
          <p:nvPr/>
        </p:nvSpPr>
        <p:spPr>
          <a:xfrm>
            <a:off x="1068759" y="2025807"/>
            <a:ext cx="639919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ntrol</a:t>
            </a:r>
            <a:endParaRPr lang="zh-CN" altLang="en-US" sz="1051" b="1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11F4105-8586-42DF-A7B7-BCCF27C87EF4}"/>
              </a:ext>
            </a:extLst>
          </p:cNvPr>
          <p:cNvSpPr txBox="1"/>
          <p:nvPr/>
        </p:nvSpPr>
        <p:spPr>
          <a:xfrm>
            <a:off x="3083439" y="2011751"/>
            <a:ext cx="1023037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Cl</a:t>
            </a:r>
            <a:r>
              <a:rPr lang="en-US" altLang="zh-CN" sz="751" b="1" dirty="0"/>
              <a:t>2</a:t>
            </a:r>
            <a:r>
              <a:rPr lang="en-US" altLang="zh-CN" sz="1051" b="1" dirty="0"/>
              <a:t> 10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8A82B46-39B0-4CC4-8A40-0102A82F7CA5}"/>
              </a:ext>
            </a:extLst>
          </p:cNvPr>
          <p:cNvSpPr txBox="1"/>
          <p:nvPr/>
        </p:nvSpPr>
        <p:spPr>
          <a:xfrm>
            <a:off x="5310919" y="2025807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1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93B96D8-559A-4ACB-8DDB-9EA018510512}"/>
              </a:ext>
            </a:extLst>
          </p:cNvPr>
          <p:cNvSpPr txBox="1"/>
          <p:nvPr/>
        </p:nvSpPr>
        <p:spPr>
          <a:xfrm>
            <a:off x="7516759" y="2025807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2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7927EABE-9523-43F1-AA89-E6735163B162}"/>
              </a:ext>
            </a:extLst>
          </p:cNvPr>
          <p:cNvSpPr txBox="1"/>
          <p:nvPr/>
        </p:nvSpPr>
        <p:spPr>
          <a:xfrm>
            <a:off x="1550504" y="259002"/>
            <a:ext cx="639919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ntrol</a:t>
            </a:r>
            <a:endParaRPr lang="zh-CN" altLang="en-US" sz="1051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1C91504-290B-4AB7-ACAD-B54564F084F7}"/>
              </a:ext>
            </a:extLst>
          </p:cNvPr>
          <p:cNvSpPr txBox="1"/>
          <p:nvPr/>
        </p:nvSpPr>
        <p:spPr>
          <a:xfrm>
            <a:off x="3098115" y="259000"/>
            <a:ext cx="1023037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oCl</a:t>
            </a:r>
            <a:r>
              <a:rPr lang="en-US" altLang="zh-CN" sz="751" b="1" dirty="0"/>
              <a:t>2</a:t>
            </a:r>
            <a:r>
              <a:rPr lang="en-US" altLang="zh-CN" sz="1051" b="1" dirty="0"/>
              <a:t> 10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FD8DDB5-E719-4EE5-9424-FCD5C2822041}"/>
              </a:ext>
            </a:extLst>
          </p:cNvPr>
          <p:cNvSpPr txBox="1"/>
          <p:nvPr/>
        </p:nvSpPr>
        <p:spPr>
          <a:xfrm>
            <a:off x="5048339" y="259000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1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E46D4ED4-E0F3-4EBC-AE80-268A8D69EBAB}"/>
              </a:ext>
            </a:extLst>
          </p:cNvPr>
          <p:cNvSpPr txBox="1"/>
          <p:nvPr/>
        </p:nvSpPr>
        <p:spPr>
          <a:xfrm>
            <a:off x="6873381" y="258999"/>
            <a:ext cx="978153" cy="2540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51" b="1" dirty="0"/>
              <a:t>CANA 20 </a:t>
            </a:r>
            <a:r>
              <a:rPr lang="el-GR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0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051" b="1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E043CB8-DBD1-45F7-B341-B37E21552C85}"/>
              </a:ext>
            </a:extLst>
          </p:cNvPr>
          <p:cNvSpPr txBox="1"/>
          <p:nvPr/>
        </p:nvSpPr>
        <p:spPr>
          <a:xfrm>
            <a:off x="403515" y="1109161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34AD77B-C096-4495-8D37-89995A82292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8755" y="442089"/>
            <a:ext cx="7076844" cy="135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466EDBA-294F-4794-9BC3-9D6D3BC1552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1880" y="2277934"/>
            <a:ext cx="8365463" cy="2430000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2D1BAC3C-4B8E-4B69-A0F3-1A81F3C06BA0}"/>
              </a:ext>
            </a:extLst>
          </p:cNvPr>
          <p:cNvSpPr txBox="1"/>
          <p:nvPr/>
        </p:nvSpPr>
        <p:spPr>
          <a:xfrm>
            <a:off x="835674" y="5152555"/>
            <a:ext cx="7686603" cy="7159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2 CANA inhibited hypoxia-induced metastasis in HCCLM3 cells. (A) </a:t>
            </a:r>
            <a:r>
              <a:rPr lang="en-US" altLang="zh-CN" sz="1351" dirty="0" err="1"/>
              <a:t>Transwell</a:t>
            </a:r>
            <a:r>
              <a:rPr lang="en-US" altLang="zh-CN" sz="1351" dirty="0"/>
              <a:t>  and (B)wound healing assays  were performed to determine the migration of HCCLM3 cells. Control, normal untreated control; CANA, CANA-treated CoCl</a:t>
            </a:r>
            <a:r>
              <a:rPr lang="en-US" altLang="zh-CN" sz="10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  <a:endParaRPr lang="zh-CN" altLang="en-US" sz="1351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C32DBC03-F190-4C31-BB4A-683A7E9ED6D6}"/>
              </a:ext>
            </a:extLst>
          </p:cNvPr>
          <p:cNvSpPr txBox="1"/>
          <p:nvPr/>
        </p:nvSpPr>
        <p:spPr>
          <a:xfrm>
            <a:off x="180283" y="68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BFEA09E-454F-4DDE-AE6D-C17ABF7FE287}"/>
              </a:ext>
            </a:extLst>
          </p:cNvPr>
          <p:cNvSpPr txBox="1"/>
          <p:nvPr/>
        </p:nvSpPr>
        <p:spPr>
          <a:xfrm>
            <a:off x="180283" y="184923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53853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文本框 11">
            <a:extLst>
              <a:ext uri="{FF2B5EF4-FFF2-40B4-BE49-F238E27FC236}">
                <a16:creationId xmlns:a16="http://schemas.microsoft.com/office/drawing/2014/main" id="{DAD76705-276C-44D2-A51C-04F01E8E36D9}"/>
              </a:ext>
            </a:extLst>
          </p:cNvPr>
          <p:cNvSpPr txBox="1"/>
          <p:nvPr/>
        </p:nvSpPr>
        <p:spPr>
          <a:xfrm>
            <a:off x="917912" y="555563"/>
            <a:ext cx="837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ontrol</a:t>
            </a:r>
            <a:endParaRPr lang="zh-CN" altLang="en-US" sz="1500" b="1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CFF9EC03-02CA-4ABD-8D84-E6AD1D30B77C}"/>
              </a:ext>
            </a:extLst>
          </p:cNvPr>
          <p:cNvSpPr txBox="1"/>
          <p:nvPr/>
        </p:nvSpPr>
        <p:spPr>
          <a:xfrm>
            <a:off x="2823566" y="555565"/>
            <a:ext cx="13531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b="1" dirty="0"/>
              <a:t>CoCl</a:t>
            </a:r>
            <a:r>
              <a:rPr lang="en-US" altLang="zh-CN" sz="900" b="1" dirty="0"/>
              <a:t>2</a:t>
            </a:r>
            <a:r>
              <a:rPr lang="en-US" altLang="zh-CN" sz="1500" b="1" dirty="0"/>
              <a:t> 10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1DB90BBD-03BD-42BE-A67E-72B40669F87B}"/>
              </a:ext>
            </a:extLst>
          </p:cNvPr>
          <p:cNvSpPr txBox="1"/>
          <p:nvPr/>
        </p:nvSpPr>
        <p:spPr>
          <a:xfrm>
            <a:off x="5043495" y="555563"/>
            <a:ext cx="13227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ANA 1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715E49C-762A-44FC-9A1A-BE6F59ABFC95}"/>
              </a:ext>
            </a:extLst>
          </p:cNvPr>
          <p:cNvSpPr txBox="1"/>
          <p:nvPr/>
        </p:nvSpPr>
        <p:spPr>
          <a:xfrm>
            <a:off x="7283365" y="555563"/>
            <a:ext cx="13227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ANA 2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B3C93465-DB58-4809-8E7C-B7707BE0B1ED}"/>
              </a:ext>
            </a:extLst>
          </p:cNvPr>
          <p:cNvCxnSpPr/>
          <p:nvPr/>
        </p:nvCxnSpPr>
        <p:spPr>
          <a:xfrm>
            <a:off x="537702" y="499612"/>
            <a:ext cx="785653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6F422A5C-C7A1-4011-B85E-B161B5BE4F19}"/>
              </a:ext>
            </a:extLst>
          </p:cNvPr>
          <p:cNvSpPr txBox="1"/>
          <p:nvPr/>
        </p:nvSpPr>
        <p:spPr>
          <a:xfrm>
            <a:off x="2457903" y="188573"/>
            <a:ext cx="45127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Hep3B cell culture supernatant +HUVECS</a:t>
            </a:r>
            <a:endParaRPr lang="zh-CN" altLang="en-US" b="1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1E67530-B3DB-4D62-8B99-4C7BEFF405A5}"/>
              </a:ext>
            </a:extLst>
          </p:cNvPr>
          <p:cNvSpPr txBox="1"/>
          <p:nvPr/>
        </p:nvSpPr>
        <p:spPr>
          <a:xfrm>
            <a:off x="339050" y="5934157"/>
            <a:ext cx="8600739" cy="9238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3 CANA inhibited hypoxia-induced angiogenesis. Hep3B or HCCLM3  cells were cultured in DMEM medium or CoCl</a:t>
            </a:r>
            <a:r>
              <a:rPr lang="en-US" altLang="zh-CN" sz="900" dirty="0"/>
              <a:t>2</a:t>
            </a:r>
            <a:r>
              <a:rPr lang="en-US" altLang="zh-CN" sz="1351" dirty="0"/>
              <a:t> 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 and CANA (10 or 2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 for 24 h to obtain the condition medium. Tube formation was performed with Hep3B(A) or HCCLM3(B) cell culture supernatant to determine the angiogenic ability of HUVECs. Control, normal untreated control; CANA, CANA-treated CoCl2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  <a:endParaRPr lang="zh-CN" altLang="en-US" dirty="0"/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DDE63195-1909-4ABF-9F4C-8B18135AAE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830" y="3773230"/>
            <a:ext cx="8654339" cy="1960577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32C40DDC-C195-42D2-9EBE-C3C549792F4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7178" y="868944"/>
            <a:ext cx="8595814" cy="1975208"/>
          </a:xfrm>
          <a:prstGeom prst="rect">
            <a:avLst/>
          </a:prstGeom>
        </p:spPr>
      </p:pic>
      <p:sp>
        <p:nvSpPr>
          <p:cNvPr id="46" name="文本框 45">
            <a:extLst>
              <a:ext uri="{FF2B5EF4-FFF2-40B4-BE49-F238E27FC236}">
                <a16:creationId xmlns:a16="http://schemas.microsoft.com/office/drawing/2014/main" id="{3D4B33E1-81C1-4886-A7C2-0057445CAB61}"/>
              </a:ext>
            </a:extLst>
          </p:cNvPr>
          <p:cNvSpPr txBox="1"/>
          <p:nvPr/>
        </p:nvSpPr>
        <p:spPr>
          <a:xfrm>
            <a:off x="973494" y="3459849"/>
            <a:ext cx="837089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ontrol</a:t>
            </a:r>
            <a:endParaRPr lang="zh-CN" altLang="en-US" sz="1500" b="1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90D29BF8-4A5B-49FE-83AB-AF47DCB9A0AC}"/>
              </a:ext>
            </a:extLst>
          </p:cNvPr>
          <p:cNvSpPr txBox="1"/>
          <p:nvPr/>
        </p:nvSpPr>
        <p:spPr>
          <a:xfrm>
            <a:off x="2879148" y="3459851"/>
            <a:ext cx="13531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b="1" dirty="0"/>
              <a:t>CoCl</a:t>
            </a:r>
            <a:r>
              <a:rPr lang="en-US" altLang="zh-CN" sz="900" b="1" dirty="0"/>
              <a:t>2</a:t>
            </a:r>
            <a:r>
              <a:rPr lang="en-US" altLang="zh-CN" sz="1500" b="1" dirty="0"/>
              <a:t> 10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126698DC-85B7-4319-8AE5-B006D13FE307}"/>
              </a:ext>
            </a:extLst>
          </p:cNvPr>
          <p:cNvSpPr txBox="1"/>
          <p:nvPr/>
        </p:nvSpPr>
        <p:spPr>
          <a:xfrm>
            <a:off x="5099077" y="3459849"/>
            <a:ext cx="13227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ANA 1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7E1EE1D-0874-4F50-B362-FD056D30F4F2}"/>
              </a:ext>
            </a:extLst>
          </p:cNvPr>
          <p:cNvSpPr txBox="1"/>
          <p:nvPr/>
        </p:nvSpPr>
        <p:spPr>
          <a:xfrm>
            <a:off x="7338947" y="3459849"/>
            <a:ext cx="13227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ANA 2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cxnSp>
        <p:nvCxnSpPr>
          <p:cNvPr id="50" name="直接连接符 49">
            <a:extLst>
              <a:ext uri="{FF2B5EF4-FFF2-40B4-BE49-F238E27FC236}">
                <a16:creationId xmlns:a16="http://schemas.microsoft.com/office/drawing/2014/main" id="{1C9774D7-D554-4C5D-9F11-D6A0931431F2}"/>
              </a:ext>
            </a:extLst>
          </p:cNvPr>
          <p:cNvCxnSpPr/>
          <p:nvPr/>
        </p:nvCxnSpPr>
        <p:spPr>
          <a:xfrm>
            <a:off x="593284" y="3403898"/>
            <a:ext cx="785653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文本框 50">
            <a:extLst>
              <a:ext uri="{FF2B5EF4-FFF2-40B4-BE49-F238E27FC236}">
                <a16:creationId xmlns:a16="http://schemas.microsoft.com/office/drawing/2014/main" id="{2F3731A6-7708-4E61-A64D-4C5FFF9A4795}"/>
              </a:ext>
            </a:extLst>
          </p:cNvPr>
          <p:cNvSpPr txBox="1"/>
          <p:nvPr/>
        </p:nvSpPr>
        <p:spPr>
          <a:xfrm>
            <a:off x="2513485" y="3092859"/>
            <a:ext cx="42518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HCCLM3 cell culture supernatant +HUVECS</a:t>
            </a:r>
            <a:endParaRPr lang="zh-CN" altLang="en-US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2115164-1EDF-4A8D-870B-4953D4B63A93}"/>
              </a:ext>
            </a:extLst>
          </p:cNvPr>
          <p:cNvSpPr txBox="1"/>
          <p:nvPr/>
        </p:nvSpPr>
        <p:spPr>
          <a:xfrm>
            <a:off x="180283" y="68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A85CE27-0781-44D8-8980-3FBF46806B40}"/>
              </a:ext>
            </a:extLst>
          </p:cNvPr>
          <p:cNvSpPr txBox="1"/>
          <p:nvPr/>
        </p:nvSpPr>
        <p:spPr>
          <a:xfrm>
            <a:off x="180283" y="30928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5386709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879A54F-CA2B-4070-ADA0-B5AA1389A9F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9376" r="1743" b="11472"/>
          <a:stretch/>
        </p:blipFill>
        <p:spPr>
          <a:xfrm>
            <a:off x="3319651" y="2459942"/>
            <a:ext cx="1890000" cy="47399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4E902FC-EAB8-400B-9237-34F1116CDB8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049" t="7571" r="4730" b="11205"/>
          <a:stretch/>
        </p:blipFill>
        <p:spPr>
          <a:xfrm>
            <a:off x="3319651" y="2934101"/>
            <a:ext cx="1890000" cy="494899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4E798A1-F24A-43B4-B75F-BB0801D0B0D0}"/>
              </a:ext>
            </a:extLst>
          </p:cNvPr>
          <p:cNvSpPr txBox="1"/>
          <p:nvPr/>
        </p:nvSpPr>
        <p:spPr>
          <a:xfrm>
            <a:off x="2541964" y="3079570"/>
            <a:ext cx="744114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ACTIN</a:t>
            </a:r>
            <a:endParaRPr lang="zh-CN" altLang="en-US" sz="1500" b="1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35C0054-44FF-4431-9FE7-F65A77BB67C3}"/>
              </a:ext>
            </a:extLst>
          </p:cNvPr>
          <p:cNvSpPr txBox="1"/>
          <p:nvPr/>
        </p:nvSpPr>
        <p:spPr>
          <a:xfrm>
            <a:off x="2521481" y="2526368"/>
            <a:ext cx="80182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HIF-1</a:t>
            </a:r>
            <a:r>
              <a:rPr lang="en-US" altLang="zh-CN" sz="1500" b="1" dirty="0">
                <a:cs typeface="Times New Roman" panose="02020603050405020304" pitchFamily="18" charset="0"/>
              </a:rPr>
              <a:t>α</a:t>
            </a:r>
            <a:endParaRPr lang="zh-CN" altLang="en-US" sz="1500" b="1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3BF4210E-8908-401A-819D-E06C91D487EC}"/>
              </a:ext>
            </a:extLst>
          </p:cNvPr>
          <p:cNvSpPr txBox="1"/>
          <p:nvPr/>
        </p:nvSpPr>
        <p:spPr>
          <a:xfrm rot="19031986">
            <a:off x="3317899" y="2037134"/>
            <a:ext cx="7072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ontrol</a:t>
            </a:r>
            <a:endParaRPr lang="zh-CN" altLang="en-US" sz="1200" b="1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77A78EB-2EB8-4085-A05F-C486084A90C4}"/>
              </a:ext>
            </a:extLst>
          </p:cNvPr>
          <p:cNvSpPr txBox="1"/>
          <p:nvPr/>
        </p:nvSpPr>
        <p:spPr>
          <a:xfrm rot="19031986">
            <a:off x="3708132" y="1901750"/>
            <a:ext cx="1135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oCl</a:t>
            </a:r>
            <a:r>
              <a:rPr lang="en-US" altLang="zh-CN" sz="788" b="1" dirty="0"/>
              <a:t>2</a:t>
            </a:r>
            <a:r>
              <a:rPr lang="en-US" altLang="zh-CN" sz="1200" dirty="0"/>
              <a:t> </a:t>
            </a:r>
            <a:r>
              <a:rPr lang="en-US" altLang="zh-CN" sz="1200" b="1" dirty="0"/>
              <a:t>100 </a:t>
            </a:r>
            <a:r>
              <a:rPr lang="el-GR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200" b="1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03247FF1-CCCC-499F-A897-ED71390123BA}"/>
              </a:ext>
            </a:extLst>
          </p:cNvPr>
          <p:cNvSpPr txBox="1"/>
          <p:nvPr/>
        </p:nvSpPr>
        <p:spPr>
          <a:xfrm rot="19031986">
            <a:off x="4272127" y="1953686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ANA 10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200" b="1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76175D5-8BBD-4886-B9AB-FEF3B8A049FC}"/>
              </a:ext>
            </a:extLst>
          </p:cNvPr>
          <p:cNvSpPr txBox="1"/>
          <p:nvPr/>
        </p:nvSpPr>
        <p:spPr>
          <a:xfrm rot="19031986">
            <a:off x="4747919" y="1953686"/>
            <a:ext cx="10486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/>
              <a:t>CANA 20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endParaRPr lang="zh-CN" altLang="en-US" sz="1200" b="1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8AD043A-D8DB-495C-80CA-B3DC8444F083}"/>
              </a:ext>
            </a:extLst>
          </p:cNvPr>
          <p:cNvSpPr txBox="1"/>
          <p:nvPr/>
        </p:nvSpPr>
        <p:spPr>
          <a:xfrm>
            <a:off x="2246856" y="3840915"/>
            <a:ext cx="4572872" cy="9238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4 CANA inhibited accumulation of HIF-1α.Expression of HIF-1α protein in Hep3B cells exposed to CoCl</a:t>
            </a:r>
            <a:r>
              <a:rPr lang="en-US" altLang="zh-CN" sz="1051" dirty="0"/>
              <a:t>2</a:t>
            </a:r>
            <a:r>
              <a:rPr lang="en-US" altLang="zh-CN" sz="1351" dirty="0"/>
              <a:t> in presence or absence of CANA. Control, normal untreated control; CANA, CANA-treated CoCl2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  <a:endParaRPr lang="zh-CN" altLang="en-US" sz="1351" dirty="0"/>
          </a:p>
        </p:txBody>
      </p:sp>
    </p:spTree>
    <p:extLst>
      <p:ext uri="{BB962C8B-B14F-4D97-AF65-F5344CB8AC3E}">
        <p14:creationId xmlns:p14="http://schemas.microsoft.com/office/powerpoint/2010/main" val="19084632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文本框 12">
            <a:extLst>
              <a:ext uri="{FF2B5EF4-FFF2-40B4-BE49-F238E27FC236}">
                <a16:creationId xmlns:a16="http://schemas.microsoft.com/office/drawing/2014/main" id="{D24C5EE0-1BA1-4F6D-8AAD-0C91A5629CC1}"/>
              </a:ext>
            </a:extLst>
          </p:cNvPr>
          <p:cNvSpPr txBox="1"/>
          <p:nvPr/>
        </p:nvSpPr>
        <p:spPr>
          <a:xfrm>
            <a:off x="2949696" y="206833"/>
            <a:ext cx="116891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LW-6  10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E5AB06C9-3667-4CA7-8380-AC16714E5BCC}"/>
              </a:ext>
            </a:extLst>
          </p:cNvPr>
          <p:cNvSpPr txBox="1"/>
          <p:nvPr/>
        </p:nvSpPr>
        <p:spPr>
          <a:xfrm>
            <a:off x="5025230" y="210453"/>
            <a:ext cx="120898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CANA 2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B9E6E74-5FEC-4C92-BDC1-2266A5CDB0BD}"/>
              </a:ext>
            </a:extLst>
          </p:cNvPr>
          <p:cNvSpPr txBox="1"/>
          <p:nvPr/>
        </p:nvSpPr>
        <p:spPr>
          <a:xfrm>
            <a:off x="6605106" y="206833"/>
            <a:ext cx="227017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LW6 1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altLang="zh-CN" sz="1351" b="1" dirty="0"/>
              <a:t>+CANA 2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8E9B91C4-D0C6-421D-8085-FBF227638B50}"/>
              </a:ext>
            </a:extLst>
          </p:cNvPr>
          <p:cNvSpPr txBox="1"/>
          <p:nvPr/>
        </p:nvSpPr>
        <p:spPr>
          <a:xfrm>
            <a:off x="-59423" y="2713052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0 h</a:t>
            </a:r>
            <a:endParaRPr lang="zh-CN" altLang="en-US" sz="1200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B46DA752-C6AA-453D-BF19-3EEAC8EAF474}"/>
              </a:ext>
            </a:extLst>
          </p:cNvPr>
          <p:cNvSpPr txBox="1"/>
          <p:nvPr/>
        </p:nvSpPr>
        <p:spPr>
          <a:xfrm>
            <a:off x="-70185" y="4031119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6708F1F-9E5C-4713-B220-9BAAEBE3B59D}"/>
              </a:ext>
            </a:extLst>
          </p:cNvPr>
          <p:cNvSpPr txBox="1"/>
          <p:nvPr/>
        </p:nvSpPr>
        <p:spPr>
          <a:xfrm>
            <a:off x="2890935" y="1917476"/>
            <a:ext cx="1168910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LW-6  10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DDDC949-D5C0-4A69-899C-2A93AFDDACB0}"/>
              </a:ext>
            </a:extLst>
          </p:cNvPr>
          <p:cNvSpPr txBox="1"/>
          <p:nvPr/>
        </p:nvSpPr>
        <p:spPr>
          <a:xfrm>
            <a:off x="5105052" y="1915546"/>
            <a:ext cx="1208985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CANA 2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BDC84AE-9CC3-4C8B-9DB7-A9C2BF2FC43E}"/>
              </a:ext>
            </a:extLst>
          </p:cNvPr>
          <p:cNvSpPr txBox="1"/>
          <p:nvPr/>
        </p:nvSpPr>
        <p:spPr>
          <a:xfrm>
            <a:off x="6834734" y="1922763"/>
            <a:ext cx="2270173" cy="3002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351" b="1" dirty="0"/>
              <a:t>LW6 1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altLang="zh-CN" sz="1351" b="1" dirty="0"/>
              <a:t>+CANA 2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7B5D10A5-8F53-4AF8-B1C3-086BABA7C833}"/>
              </a:ext>
            </a:extLst>
          </p:cNvPr>
          <p:cNvSpPr txBox="1"/>
          <p:nvPr/>
        </p:nvSpPr>
        <p:spPr>
          <a:xfrm>
            <a:off x="919205" y="203074"/>
            <a:ext cx="1353112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CoCl</a:t>
            </a:r>
            <a:r>
              <a:rPr lang="en-US" altLang="zh-CN" sz="825" b="1" dirty="0"/>
              <a:t>2</a:t>
            </a:r>
            <a:r>
              <a:rPr lang="en-US" altLang="zh-CN" sz="1351" b="1" dirty="0"/>
              <a:t> 10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3671F5A4-0BE3-4A62-96D7-F8ED90B4AACD}"/>
              </a:ext>
            </a:extLst>
          </p:cNvPr>
          <p:cNvSpPr txBox="1"/>
          <p:nvPr/>
        </p:nvSpPr>
        <p:spPr>
          <a:xfrm>
            <a:off x="561044" y="1921235"/>
            <a:ext cx="1353112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CoCl</a:t>
            </a:r>
            <a:r>
              <a:rPr lang="en-US" altLang="zh-CN" sz="825" b="1" dirty="0"/>
              <a:t>2</a:t>
            </a:r>
            <a:r>
              <a:rPr lang="en-US" altLang="zh-CN" sz="1351" b="1" dirty="0"/>
              <a:t> 100 </a:t>
            </a:r>
            <a:r>
              <a:rPr lang="el-GR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35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351" b="1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56937DE9-3A20-4D1D-AF89-A049BEA1DD9D}"/>
              </a:ext>
            </a:extLst>
          </p:cNvPr>
          <p:cNvSpPr txBox="1"/>
          <p:nvPr/>
        </p:nvSpPr>
        <p:spPr>
          <a:xfrm>
            <a:off x="475726" y="5205176"/>
            <a:ext cx="8280999" cy="9238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5 The synergistic inhibitory effect of CANA and LW-6 on cell </a:t>
            </a:r>
            <a:r>
              <a:rPr lang="en-US" altLang="zh-CN" sz="1351" dirty="0" err="1"/>
              <a:t>migrationTranswell</a:t>
            </a:r>
            <a:r>
              <a:rPr lang="en-US" altLang="zh-CN" sz="1351" dirty="0"/>
              <a:t> (A) and wound healing (B) assays  were performed to determine the migration of HepG2 cells in presence of LW-6, CANA, or both. Control, normal untreated control; CANA, CANA-treated CoCl</a:t>
            </a:r>
            <a:r>
              <a:rPr lang="en-US" altLang="zh-CN" sz="9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; LW-6, LW-6-treated CoCl</a:t>
            </a:r>
            <a:r>
              <a:rPr lang="en-US" altLang="zh-CN" sz="10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; LW-6 + CANA, LW-6-treated CANA-treated CoCl</a:t>
            </a:r>
            <a:r>
              <a:rPr lang="en-US" altLang="zh-CN" sz="10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  <a:endParaRPr lang="zh-CN" altLang="en-US" sz="1351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DF7E933-5B8F-43D2-AFC8-005B40DA0CE5}"/>
              </a:ext>
            </a:extLst>
          </p:cNvPr>
          <p:cNvSpPr txBox="1"/>
          <p:nvPr/>
        </p:nvSpPr>
        <p:spPr>
          <a:xfrm>
            <a:off x="317453" y="1087643"/>
            <a:ext cx="536007" cy="300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51" b="1" dirty="0"/>
              <a:t>24 h</a:t>
            </a:r>
            <a:endParaRPr lang="zh-CN" altLang="en-US" sz="1106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A905505A-E381-48EB-BBFD-4861F7EAED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1544" y="468744"/>
            <a:ext cx="7439212" cy="1350000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80F9480-52C9-4F54-BA81-E982797BCEF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27" y="2222973"/>
            <a:ext cx="8705584" cy="2537660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A5A8F02B-3226-429E-B4EC-5C6361523198}"/>
              </a:ext>
            </a:extLst>
          </p:cNvPr>
          <p:cNvSpPr txBox="1"/>
          <p:nvPr/>
        </p:nvSpPr>
        <p:spPr>
          <a:xfrm>
            <a:off x="180283" y="68581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FC94E45-81C7-4F4A-9630-5A9B0FD3B62E}"/>
              </a:ext>
            </a:extLst>
          </p:cNvPr>
          <p:cNvSpPr txBox="1"/>
          <p:nvPr/>
        </p:nvSpPr>
        <p:spPr>
          <a:xfrm>
            <a:off x="180283" y="184923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6234426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文本框 14">
            <a:extLst>
              <a:ext uri="{FF2B5EF4-FFF2-40B4-BE49-F238E27FC236}">
                <a16:creationId xmlns:a16="http://schemas.microsoft.com/office/drawing/2014/main" id="{678D34EF-A154-4D6C-9494-8C407B8C0A39}"/>
              </a:ext>
            </a:extLst>
          </p:cNvPr>
          <p:cNvSpPr txBox="1"/>
          <p:nvPr/>
        </p:nvSpPr>
        <p:spPr>
          <a:xfrm>
            <a:off x="2854506" y="1369581"/>
            <a:ext cx="1279517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LW-6  10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FDEDE8B-4DD9-4EBF-988F-3EFB0B3C9734}"/>
              </a:ext>
            </a:extLst>
          </p:cNvPr>
          <p:cNvSpPr txBox="1"/>
          <p:nvPr/>
        </p:nvSpPr>
        <p:spPr>
          <a:xfrm>
            <a:off x="5043495" y="1369581"/>
            <a:ext cx="132279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CANA 2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A394675B-A4CB-4606-9295-3C7B49558AE0}"/>
              </a:ext>
            </a:extLst>
          </p:cNvPr>
          <p:cNvSpPr txBox="1"/>
          <p:nvPr/>
        </p:nvSpPr>
        <p:spPr>
          <a:xfrm>
            <a:off x="6613681" y="1369581"/>
            <a:ext cx="250260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500" b="1" dirty="0"/>
              <a:t>LW6 1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r>
              <a:rPr lang="en-US" altLang="zh-CN" sz="1500" b="1" dirty="0"/>
              <a:t>+CANA 2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894B721-0AE8-425C-AFA4-551DD0F8B55A}"/>
              </a:ext>
            </a:extLst>
          </p:cNvPr>
          <p:cNvCxnSpPr/>
          <p:nvPr/>
        </p:nvCxnSpPr>
        <p:spPr>
          <a:xfrm>
            <a:off x="537702" y="1334375"/>
            <a:ext cx="7856539" cy="0"/>
          </a:xfrm>
          <a:prstGeom prst="line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6D3CBC7A-0F61-4ED6-9DE6-761037EC6B8A}"/>
              </a:ext>
            </a:extLst>
          </p:cNvPr>
          <p:cNvSpPr txBox="1"/>
          <p:nvPr/>
        </p:nvSpPr>
        <p:spPr>
          <a:xfrm>
            <a:off x="2457902" y="1023335"/>
            <a:ext cx="45336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HepG2 cell culture supernatant +HUVECS</a:t>
            </a:r>
            <a:endParaRPr lang="zh-CN" altLang="en-US" b="1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DB5C1BC-D12C-4160-A78D-BA57C316C65F}"/>
              </a:ext>
            </a:extLst>
          </p:cNvPr>
          <p:cNvSpPr txBox="1"/>
          <p:nvPr/>
        </p:nvSpPr>
        <p:spPr>
          <a:xfrm>
            <a:off x="602886" y="1369582"/>
            <a:ext cx="1353112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500" b="1" dirty="0"/>
              <a:t>CoCl</a:t>
            </a:r>
            <a:r>
              <a:rPr lang="en-US" altLang="zh-CN" sz="900" b="1" dirty="0"/>
              <a:t>2</a:t>
            </a:r>
            <a:r>
              <a:rPr lang="en-US" altLang="zh-CN" sz="1500" b="1" dirty="0"/>
              <a:t> 100 </a:t>
            </a:r>
            <a:r>
              <a:rPr lang="el-GR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μ</a:t>
            </a:r>
            <a:r>
              <a:rPr lang="en-US" altLang="zh-CN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  <a:endParaRPr lang="zh-CN" altLang="en-US" sz="1500" b="1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8D95A9AE-F3A4-4FB0-A2B3-D4AA3448D5B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4827" y="1634947"/>
            <a:ext cx="8433410" cy="189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E9B49BE0-D68B-4C59-AEA0-5EFC62C864C9}"/>
              </a:ext>
            </a:extLst>
          </p:cNvPr>
          <p:cNvSpPr txBox="1"/>
          <p:nvPr/>
        </p:nvSpPr>
        <p:spPr>
          <a:xfrm>
            <a:off x="471494" y="4149369"/>
            <a:ext cx="8344397" cy="11317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351" dirty="0"/>
              <a:t>Figure S6 The synergistic inhibitory effect of CANA and LW-6 on angiogenesis. HepG2 cells were cultured in DMEM medium or CoCl</a:t>
            </a:r>
            <a:r>
              <a:rPr lang="en-US" altLang="zh-CN" sz="1050" dirty="0"/>
              <a:t>2</a:t>
            </a:r>
            <a:r>
              <a:rPr lang="en-US" altLang="zh-CN" sz="1351" dirty="0"/>
              <a:t> 100 </a:t>
            </a:r>
            <a:r>
              <a:rPr lang="el-GR" altLang="zh-CN" sz="1351" dirty="0"/>
              <a:t>μ</a:t>
            </a:r>
            <a:r>
              <a:rPr lang="en-US" altLang="zh-CN" sz="1351" dirty="0"/>
              <a:t>M and CANA (10 or 20 </a:t>
            </a:r>
            <a:r>
              <a:rPr lang="el-GR" altLang="zh-CN" sz="1351" dirty="0"/>
              <a:t>μ</a:t>
            </a:r>
            <a:r>
              <a:rPr lang="en-US" altLang="zh-CN" sz="1351" dirty="0"/>
              <a:t>M) for 24 h to obtain the condition medium. Tube formation was performed with condition medium to determine the angiogenic ability of HUVECs. CANA, CANA-treated CoCl</a:t>
            </a:r>
            <a:r>
              <a:rPr lang="en-US" altLang="zh-CN" sz="9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; LW-6, LW-6-treated CoCl</a:t>
            </a:r>
            <a:r>
              <a:rPr lang="en-US" altLang="zh-CN" sz="10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; LW-6 + CANA, LW-6-treated CANA-treated CoCl</a:t>
            </a:r>
            <a:r>
              <a:rPr lang="en-US" altLang="zh-CN" sz="1000" dirty="0"/>
              <a:t>2</a:t>
            </a:r>
            <a:r>
              <a:rPr lang="en-US" altLang="zh-CN" sz="1351" dirty="0"/>
              <a:t> (100 </a:t>
            </a:r>
            <a:r>
              <a:rPr lang="en-US" altLang="zh-CN" sz="1351" dirty="0" err="1"/>
              <a:t>μM</a:t>
            </a:r>
            <a:r>
              <a:rPr lang="en-US" altLang="zh-CN" sz="1351" dirty="0"/>
              <a:t>)-induced group.</a:t>
            </a:r>
          </a:p>
        </p:txBody>
      </p:sp>
    </p:spTree>
    <p:extLst>
      <p:ext uri="{BB962C8B-B14F-4D97-AF65-F5344CB8AC3E}">
        <p14:creationId xmlns:p14="http://schemas.microsoft.com/office/powerpoint/2010/main" val="6393326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91</TotalTime>
  <Words>591</Words>
  <Application>Microsoft Office PowerPoint</Application>
  <PresentationFormat>全屏显示(4:3)</PresentationFormat>
  <Paragraphs>68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ngyi Luo</dc:creator>
  <cp:lastModifiedBy>Jingyi Luo</cp:lastModifiedBy>
  <cp:revision>16</cp:revision>
  <dcterms:created xsi:type="dcterms:W3CDTF">2021-11-28T12:43:05Z</dcterms:created>
  <dcterms:modified xsi:type="dcterms:W3CDTF">2021-12-03T15:24:45Z</dcterms:modified>
</cp:coreProperties>
</file>